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410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52" autoAdjust="0"/>
    <p:restoredTop sz="96101" autoAdjust="0"/>
  </p:normalViewPr>
  <p:slideViewPr>
    <p:cSldViewPr snapToGrid="0">
      <p:cViewPr varScale="1">
        <p:scale>
          <a:sx n="56" d="100"/>
          <a:sy n="56" d="100"/>
        </p:scale>
        <p:origin x="240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3D075D-3051-4CD2-A528-6D9C6E322715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C721C7-53BE-47C3-B7D2-F462FD0E44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8489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15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077" algn="l" defTabSz="91415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153" algn="l" defTabSz="91415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230" algn="l" defTabSz="91415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306" algn="l" defTabSz="91415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382" algn="l" defTabSz="91415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459" algn="l" defTabSz="91415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536" algn="l" defTabSz="91415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611" algn="l" defTabSz="91415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672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806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538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566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606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678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737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093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031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32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882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1129D6-E965-44B4-BA86-512BC30C8DEC}" type="datetimeFigureOut">
              <a:rPr lang="en-US" smtClean="0"/>
              <a:t>10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43C1B-B62F-47F3-B820-410BD7B9B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392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0269" y="3133882"/>
            <a:ext cx="1935994" cy="1958419"/>
          </a:xfrm>
          <a:prstGeom prst="rect">
            <a:avLst/>
          </a:prstGeom>
        </p:spPr>
      </p:pic>
      <p:sp>
        <p:nvSpPr>
          <p:cNvPr id="2" name="TextBox 3">
            <a:extLst>
              <a:ext uri="{FF2B5EF4-FFF2-40B4-BE49-F238E27FC236}">
                <a16:creationId xmlns:a16="http://schemas.microsoft.com/office/drawing/2014/main" xmlns="" id="{C2845FCF-2A89-4A4E-964D-473F79A7F3BF}"/>
              </a:ext>
            </a:extLst>
          </p:cNvPr>
          <p:cNvSpPr txBox="1"/>
          <p:nvPr/>
        </p:nvSpPr>
        <p:spPr>
          <a:xfrm>
            <a:off x="138112" y="5485896"/>
            <a:ext cx="6581775" cy="13042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1: Representative FACS analyses of </a:t>
            </a:r>
            <a:r>
              <a:rPr lang="en-US" sz="1200" b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pCAM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CD49f expression in cells isolated from control and treated patient samples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US" sz="1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ates identifying luminal progenitor (LP), mature luminal (ML), and basal myoepithelial (BM) populations are shown which were derived from Lin</a:t>
            </a:r>
            <a:r>
              <a:rPr lang="en-US" sz="1200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ating using Streptavidin-Brilliant Violet 605. FITC, fluorescein isothiocyanate; APC,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llophycocyanin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endParaRPr lang="en-US" sz="1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xmlns="" id="{218218CF-D2C7-93EC-DCA8-42C8F8D053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8068" y="97523"/>
            <a:ext cx="6524979" cy="787558"/>
          </a:xfrm>
        </p:spPr>
        <p:txBody>
          <a:bodyPr>
            <a:normAutofit fontScale="90000"/>
          </a:bodyPr>
          <a:lstStyle/>
          <a:p>
            <a:r>
              <a:rPr lang="en-US" sz="2112" dirty="0"/>
              <a:t>Supplementary Figure 1: Representative FACS analyses of </a:t>
            </a:r>
            <a:r>
              <a:rPr lang="en-US" sz="2112" dirty="0" err="1"/>
              <a:t>EpCAM</a:t>
            </a:r>
            <a:r>
              <a:rPr lang="en-US" sz="2112" dirty="0"/>
              <a:t> and CD49f expression in cells isolated from control and treated patient samples. </a:t>
            </a:r>
          </a:p>
        </p:txBody>
      </p:sp>
    </p:spTree>
    <p:extLst>
      <p:ext uri="{BB962C8B-B14F-4D97-AF65-F5344CB8AC3E}">
        <p14:creationId xmlns:p14="http://schemas.microsoft.com/office/powerpoint/2010/main" val="914845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914</TotalTime>
  <Words>85</Words>
  <Application>Microsoft Office PowerPoint</Application>
  <PresentationFormat>Letter Paper (8.5x11 in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Supplementary Figure 1: Representative FACS analyses of EpCAM and CD49f expression in cells isolated from control and treated patient samples. 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pa Human Paper Figures</dc:title>
  <dc:creator>Lawrence Meadonia</dc:creator>
  <cp:lastModifiedBy>Saranya Suresh</cp:lastModifiedBy>
  <cp:revision>506</cp:revision>
  <dcterms:created xsi:type="dcterms:W3CDTF">2021-02-24T20:56:34Z</dcterms:created>
  <dcterms:modified xsi:type="dcterms:W3CDTF">2023-10-11T12:48:14Z</dcterms:modified>
</cp:coreProperties>
</file>